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1" autoAdjust="0"/>
    <p:restoredTop sz="94660"/>
  </p:normalViewPr>
  <p:slideViewPr>
    <p:cSldViewPr snapToGrid="0">
      <p:cViewPr>
        <p:scale>
          <a:sx n="400" d="100"/>
          <a:sy n="400" d="100"/>
        </p:scale>
        <p:origin x="-12018" y="-59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840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2953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42260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8192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07401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074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5315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07864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5021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8086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86712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69327-64D2-4107-AC8F-EC6B513A0DAF}" type="datetimeFigureOut">
              <a:rPr lang="zh-TW" altLang="en-US" smtClean="0"/>
              <a:t>2022/3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54B94-B7CC-4835-B474-CE244FC6EC6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07860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9804" y="684779"/>
            <a:ext cx="5992584" cy="3771839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068905" y="4552879"/>
            <a:ext cx="779899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 image of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Vs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paration in isolate ATCC 50148. Virus-like particles (VLPs) were found in diameter between 30 to 40 nm surrounding the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Vs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presentative VLPs were shown as enclosed in the square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riginal magnification, × 60,000; scale bar = 100 nm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單箭頭接點 7"/>
          <p:cNvCxnSpPr/>
          <p:nvPr/>
        </p:nvCxnSpPr>
        <p:spPr>
          <a:xfrm flipH="1">
            <a:off x="6216819" y="2025883"/>
            <a:ext cx="273812" cy="20335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9" name="文字方塊 8"/>
          <p:cNvSpPr txBox="1"/>
          <p:nvPr/>
        </p:nvSpPr>
        <p:spPr>
          <a:xfrm>
            <a:off x="6280319" y="1761584"/>
            <a:ext cx="1060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s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單箭頭接點 9"/>
          <p:cNvCxnSpPr/>
          <p:nvPr/>
        </p:nvCxnSpPr>
        <p:spPr>
          <a:xfrm flipH="1">
            <a:off x="7514772" y="2499231"/>
            <a:ext cx="203200" cy="18466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1" name="矩形 10"/>
          <p:cNvSpPr/>
          <p:nvPr/>
        </p:nvSpPr>
        <p:spPr>
          <a:xfrm flipH="1">
            <a:off x="7543800" y="2229234"/>
            <a:ext cx="11744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s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單箭頭接點 11"/>
          <p:cNvCxnSpPr/>
          <p:nvPr/>
        </p:nvCxnSpPr>
        <p:spPr>
          <a:xfrm flipH="1" flipV="1">
            <a:off x="4408576" y="3380672"/>
            <a:ext cx="259588" cy="28483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4186936" y="3617514"/>
            <a:ext cx="1060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s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5964046" y="2529614"/>
            <a:ext cx="1053169" cy="84372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cxnSp>
        <p:nvCxnSpPr>
          <p:cNvPr id="13" name="直線單箭頭接點 12"/>
          <p:cNvCxnSpPr/>
          <p:nvPr/>
        </p:nvCxnSpPr>
        <p:spPr>
          <a:xfrm flipH="1" flipV="1">
            <a:off x="7017216" y="3346949"/>
            <a:ext cx="323807" cy="17412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5" name="文字方塊 14"/>
          <p:cNvSpPr txBox="1"/>
          <p:nvPr/>
        </p:nvSpPr>
        <p:spPr>
          <a:xfrm>
            <a:off x="7153180" y="3490765"/>
            <a:ext cx="1060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LPs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2426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56</Words>
  <Application>Microsoft Office PowerPoint</Application>
  <PresentationFormat>寬螢幕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SEOW CHIN ONG</dc:creator>
  <cp:lastModifiedBy>SEOW CHIN ONG</cp:lastModifiedBy>
  <cp:revision>9</cp:revision>
  <dcterms:created xsi:type="dcterms:W3CDTF">2022-03-11T05:15:05Z</dcterms:created>
  <dcterms:modified xsi:type="dcterms:W3CDTF">2022-03-11T06:36:00Z</dcterms:modified>
</cp:coreProperties>
</file>